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3" d="100"/>
          <a:sy n="83" d="100"/>
        </p:scale>
        <p:origin x="65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A6C4BE-ACD9-A307-A722-9FE3BB17BF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CB5759-61D5-DC53-4214-9A24C1CB42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334DCB-39FD-8883-15EF-17CEC79E4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7F33C9-6BF8-8EAA-EB4E-899AE159B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23C495-4615-342A-9172-A16E318BB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9135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AB048-F72A-D956-BC7E-917BF6AB9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62D0D2-D181-4825-8E7F-E73AA3E377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8D6C4E-1048-7DF9-BE50-BBF87FB5D3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6001F-D91E-74A0-64B9-611E4B71C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91785C-F84F-F462-80BA-3A55B9D09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9890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DB9E37-D915-CFE4-D64E-6E9058C69A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70B146-E0EE-1E52-E9DE-C6D52DEB2E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C3EB37-847A-C18E-AB6E-E50BC061F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8FC653-1067-2336-3593-36E96A4E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CDA168-8D14-D17A-1631-3650B4D2A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48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2B29C1-9A75-7018-BA25-212DC89FAD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5772A8-F070-F9B6-D3A4-A9110C06EE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AF69A1-BD07-4B98-8F3F-4E5B87D78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AD6EDC-D503-6AFB-3679-043576904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453AE-A316-D1D2-AA43-754209774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1387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6FBB3-30D0-6A54-00BB-8BA66147DA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00A356-E434-00A2-73CE-EA40A2AF6E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6FC1A6-45AF-F314-E520-E708D77E8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8404A6-C5AE-0FBD-ADE2-01E677F1D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512A9A-D2B1-AB13-34D5-03CE21311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4684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5B4338-F8AB-02B9-A608-322D5E65EE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3410FF-ADFC-DBED-B0D2-3637673040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636F74-4FD8-12FE-837C-6DDDC94C6D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BDFDAC-1DE5-445A-05C4-81C321834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A29AD1-8C93-3A44-B09B-9C66BADEB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B1E7FC-9A83-85A0-A288-700D3370B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89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4FC9E7-3321-23B0-A1BE-A3665A98CE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332FCD-5924-9F79-A104-5838E05D33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BAF2A7-1139-A77B-E559-753EF8BB13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9F7440-3975-6276-8163-365552D690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C5C4E2-E917-98BE-9492-3EAAA9A460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6A644C-1E3D-9E6C-36F2-DB4C45B9E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0D8E5D-AAE1-A87B-DADA-8F1DF2640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AC9874-D3DC-9C21-E5B6-1AD07BFD2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7382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160CF0-49DF-35D2-15E0-C62764D152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DB05F3-6FC6-281C-FF8E-0ACCDCA10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9EBC31-78E8-AA7C-05C6-85AFEA80D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0B50C1-6862-0CB9-1500-63AD63C2D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0137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0229198-0207-09EB-95C1-9532C622A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0BAC58-078B-4E5F-BD45-CCF13D29A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FD8C25-90E6-1991-A5A4-7A4A13C51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453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457661-263D-2204-B11A-6A1910461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FC539B-C111-CE3F-71C7-D64F239276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93CBF1-D2C8-EBD0-9944-9770CFF033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CAC2CB-ED00-ACAA-A300-9CE4F1449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E51E2C-5FC9-42DF-BA1A-4059703BF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6D1F05-FDF0-BBE7-58A9-C61EC1EE5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77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B231D7-1765-70C7-7A7D-7DF658387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7857F8-D5C2-CD0F-ECA6-246D9C1FC5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B5DB99-0E6C-27D8-9E6A-E0CD95A89B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768D5B-B171-507E-1017-1148491F9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829964-25F1-26AF-5B32-2DD7C677E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4822D-D312-CDCC-B98E-9F56F41CD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945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3C6C2C-962F-C8C0-B49D-B2620F560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91A4C9-2F25-B951-DB67-19C9BF8F2D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2762F-F723-63DF-78C2-9733F90E03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C216DD-0BF5-4489-8BC8-F745BD5A83FD}" type="datetimeFigureOut">
              <a:rPr lang="en-GB" smtClean="0"/>
              <a:t>31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659B7B-E1DD-1052-5C1D-04DB4DCB00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1C520D-3956-10BC-3230-564ACBA5F9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82B554-326D-42A3-B580-3371C201FF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197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6CE7767-8A12-E27B-F889-18DFC7D1C296}"/>
              </a:ext>
            </a:extLst>
          </p:cNvPr>
          <p:cNvSpPr txBox="1"/>
          <p:nvPr/>
        </p:nvSpPr>
        <p:spPr>
          <a:xfrm>
            <a:off x="0" y="126459"/>
            <a:ext cx="2286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CT116_biological replicate_n1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0045D26-190F-E9F9-5D51-FB63858CF7C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-657" t="862" r="-545" b="425"/>
          <a:stretch/>
        </p:blipFill>
        <p:spPr>
          <a:xfrm>
            <a:off x="5683675" y="613053"/>
            <a:ext cx="5243209" cy="2815947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293377B-65DF-A94F-5776-ECBB9B5E775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-165" t="821" r="-129" b="-323"/>
          <a:stretch/>
        </p:blipFill>
        <p:spPr>
          <a:xfrm>
            <a:off x="116733" y="3784060"/>
            <a:ext cx="4951378" cy="2947481"/>
          </a:xfrm>
          <a:prstGeom prst="rect">
            <a:avLst/>
          </a:prstGeom>
          <a:ln>
            <a:noFill/>
          </a:ln>
        </p:spPr>
      </p:pic>
      <p:pic>
        <p:nvPicPr>
          <p:cNvPr id="9" name="Picture 8" descr="A picture containing white, black, black and white&#10;&#10;Description automatically generated">
            <a:extLst>
              <a:ext uri="{FF2B5EF4-FFF2-40B4-BE49-F238E27FC236}">
                <a16:creationId xmlns:a16="http://schemas.microsoft.com/office/drawing/2014/main" id="{8852E2FA-2ABB-9796-346E-2FBC0657C81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71" t="-218" r="-112" b="127"/>
          <a:stretch/>
        </p:blipFill>
        <p:spPr>
          <a:xfrm>
            <a:off x="0" y="849484"/>
            <a:ext cx="5068111" cy="2934576"/>
          </a:xfrm>
          <a:prstGeom prst="rect">
            <a:avLst/>
          </a:prstGeom>
          <a:ln>
            <a:noFill/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1526B531-A734-ACFD-C397-DBF145BA0BD1}"/>
              </a:ext>
            </a:extLst>
          </p:cNvPr>
          <p:cNvSpPr/>
          <p:nvPr/>
        </p:nvSpPr>
        <p:spPr>
          <a:xfrm>
            <a:off x="1755843" y="1780162"/>
            <a:ext cx="953310" cy="2089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2CB75C-BADA-1B16-5CB8-9D6AE345E6E3}"/>
              </a:ext>
            </a:extLst>
          </p:cNvPr>
          <p:cNvSpPr txBox="1"/>
          <p:nvPr/>
        </p:nvSpPr>
        <p:spPr>
          <a:xfrm>
            <a:off x="1003570" y="174611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D1AC615-81E6-79F2-8FB1-2BAC7F7352E6}"/>
              </a:ext>
            </a:extLst>
          </p:cNvPr>
          <p:cNvSpPr/>
          <p:nvPr/>
        </p:nvSpPr>
        <p:spPr>
          <a:xfrm>
            <a:off x="6295417" y="1293779"/>
            <a:ext cx="1554803" cy="254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F0BE2F-49BC-92AA-0E73-AA2C21144753}"/>
              </a:ext>
            </a:extLst>
          </p:cNvPr>
          <p:cNvSpPr txBox="1"/>
          <p:nvPr/>
        </p:nvSpPr>
        <p:spPr>
          <a:xfrm>
            <a:off x="7850220" y="1339985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ERK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5966370-2A50-3381-D975-023216AB7280}"/>
              </a:ext>
            </a:extLst>
          </p:cNvPr>
          <p:cNvSpPr/>
          <p:nvPr/>
        </p:nvSpPr>
        <p:spPr>
          <a:xfrm>
            <a:off x="662555" y="5295329"/>
            <a:ext cx="1554803" cy="254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8E6D85-27FF-AF3F-070D-8F1BDC2773AB}"/>
              </a:ext>
            </a:extLst>
          </p:cNvPr>
          <p:cNvSpPr txBox="1"/>
          <p:nvPr/>
        </p:nvSpPr>
        <p:spPr>
          <a:xfrm>
            <a:off x="63232" y="5302054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680462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025388-100C-73A3-A212-32F8232B8E6E}"/>
              </a:ext>
            </a:extLst>
          </p:cNvPr>
          <p:cNvSpPr txBox="1"/>
          <p:nvPr/>
        </p:nvSpPr>
        <p:spPr>
          <a:xfrm>
            <a:off x="0" y="126459"/>
            <a:ext cx="2286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CT116_biological replicate_n2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0B11EAC-3701-18DB-1C02-87E75985824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-657" t="862" r="-545" b="425"/>
          <a:stretch/>
        </p:blipFill>
        <p:spPr>
          <a:xfrm>
            <a:off x="5184844" y="685785"/>
            <a:ext cx="5243209" cy="2815947"/>
          </a:xfrm>
          <a:prstGeom prst="rect">
            <a:avLst/>
          </a:prstGeom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F4A94B6-8979-0BE0-A6F0-B69D84E75EE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-165" t="821" r="-129" b="-323"/>
          <a:stretch/>
        </p:blipFill>
        <p:spPr>
          <a:xfrm>
            <a:off x="116733" y="3784060"/>
            <a:ext cx="4951378" cy="2947481"/>
          </a:xfrm>
          <a:prstGeom prst="rect">
            <a:avLst/>
          </a:prstGeom>
          <a:ln>
            <a:noFill/>
          </a:ln>
        </p:spPr>
      </p:pic>
      <p:pic>
        <p:nvPicPr>
          <p:cNvPr id="11" name="Picture 10" descr="A picture containing white, black, black and white&#10;&#10;Description automatically generated">
            <a:extLst>
              <a:ext uri="{FF2B5EF4-FFF2-40B4-BE49-F238E27FC236}">
                <a16:creationId xmlns:a16="http://schemas.microsoft.com/office/drawing/2014/main" id="{D7215B22-3DDE-9600-FFE3-BE211CFDC6B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71" t="-218" r="-112" b="127"/>
          <a:stretch/>
        </p:blipFill>
        <p:spPr>
          <a:xfrm>
            <a:off x="116733" y="626471"/>
            <a:ext cx="5068111" cy="2934576"/>
          </a:xfrm>
          <a:prstGeom prst="rect">
            <a:avLst/>
          </a:prstGeom>
          <a:ln>
            <a:noFill/>
          </a:ln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4B980867-33BB-E2D7-3E29-8F33BD7A01CA}"/>
              </a:ext>
            </a:extLst>
          </p:cNvPr>
          <p:cNvSpPr/>
          <p:nvPr/>
        </p:nvSpPr>
        <p:spPr>
          <a:xfrm>
            <a:off x="2738336" y="1605064"/>
            <a:ext cx="953310" cy="2089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4C0BF7-02F5-9178-EB7F-439766A8FE5C}"/>
              </a:ext>
            </a:extLst>
          </p:cNvPr>
          <p:cNvSpPr txBox="1"/>
          <p:nvPr/>
        </p:nvSpPr>
        <p:spPr>
          <a:xfrm>
            <a:off x="3691646" y="1571016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40A2E89-C0AB-7ABF-0543-78A58503D8B2}"/>
              </a:ext>
            </a:extLst>
          </p:cNvPr>
          <p:cNvSpPr/>
          <p:nvPr/>
        </p:nvSpPr>
        <p:spPr>
          <a:xfrm>
            <a:off x="7725383" y="1340464"/>
            <a:ext cx="1627806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7B9A4FA-33B0-6772-33E7-A4EE634CE722}"/>
              </a:ext>
            </a:extLst>
          </p:cNvPr>
          <p:cNvSpPr txBox="1"/>
          <p:nvPr/>
        </p:nvSpPr>
        <p:spPr>
          <a:xfrm>
            <a:off x="9453664" y="1328065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ERK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819FAAB-374C-E62B-DB48-AC807279064B}"/>
              </a:ext>
            </a:extLst>
          </p:cNvPr>
          <p:cNvSpPr/>
          <p:nvPr/>
        </p:nvSpPr>
        <p:spPr>
          <a:xfrm>
            <a:off x="2437589" y="5286984"/>
            <a:ext cx="1696666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710060-DAFB-98C0-A8EE-B7D1585E8E2E}"/>
              </a:ext>
            </a:extLst>
          </p:cNvPr>
          <p:cNvSpPr txBox="1"/>
          <p:nvPr/>
        </p:nvSpPr>
        <p:spPr>
          <a:xfrm>
            <a:off x="4134255" y="5257800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39335428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80D0578-C285-9FA0-751A-F354A81DD7E8}"/>
              </a:ext>
            </a:extLst>
          </p:cNvPr>
          <p:cNvSpPr txBox="1"/>
          <p:nvPr/>
        </p:nvSpPr>
        <p:spPr>
          <a:xfrm>
            <a:off x="0" y="126459"/>
            <a:ext cx="2286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CT116_biological replicate_n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B7F7C60-C962-5089-549E-A0C71346C39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l="-98" t="117" r="220" b="-406"/>
          <a:stretch/>
        </p:blipFill>
        <p:spPr>
          <a:xfrm>
            <a:off x="505838" y="3774333"/>
            <a:ext cx="4776280" cy="2840476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FEB716F-4666-A7EE-C5AA-3166D01AD66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/>
          <a:srcRect l="-679" t="137" r="-3" b="-657"/>
          <a:stretch/>
        </p:blipFill>
        <p:spPr>
          <a:xfrm>
            <a:off x="5846323" y="518710"/>
            <a:ext cx="5038928" cy="2662234"/>
          </a:xfrm>
          <a:prstGeom prst="rect">
            <a:avLst/>
          </a:prstGeom>
          <a:ln>
            <a:noFill/>
          </a:ln>
        </p:spPr>
      </p:pic>
      <p:pic>
        <p:nvPicPr>
          <p:cNvPr id="7" name="Picture 6" descr="A picture containing white, black&#10;&#10;Description automatically generated">
            <a:extLst>
              <a:ext uri="{FF2B5EF4-FFF2-40B4-BE49-F238E27FC236}">
                <a16:creationId xmlns:a16="http://schemas.microsoft.com/office/drawing/2014/main" id="{CA9CF0BB-9376-3750-0220-9D4537D5DBD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6" t="-37" r="-417" b="-747"/>
          <a:stretch/>
        </p:blipFill>
        <p:spPr>
          <a:xfrm>
            <a:off x="184824" y="604595"/>
            <a:ext cx="4870315" cy="2673626"/>
          </a:xfrm>
          <a:prstGeom prst="rect">
            <a:avLst/>
          </a:prstGeom>
          <a:ln>
            <a:noFill/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69A3CD00-C220-0412-B8A0-169E392A4611}"/>
              </a:ext>
            </a:extLst>
          </p:cNvPr>
          <p:cNvSpPr/>
          <p:nvPr/>
        </p:nvSpPr>
        <p:spPr>
          <a:xfrm>
            <a:off x="2856223" y="1722211"/>
            <a:ext cx="953310" cy="2089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0AFBB6E-4E7F-DA27-5B46-1EB22AB233BA}"/>
              </a:ext>
            </a:extLst>
          </p:cNvPr>
          <p:cNvSpPr txBox="1"/>
          <p:nvPr/>
        </p:nvSpPr>
        <p:spPr>
          <a:xfrm>
            <a:off x="3809533" y="171132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MHC I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31A0B65-6478-9998-3662-CF0DBDFDAB36}"/>
              </a:ext>
            </a:extLst>
          </p:cNvPr>
          <p:cNvSpPr/>
          <p:nvPr/>
        </p:nvSpPr>
        <p:spPr>
          <a:xfrm>
            <a:off x="8555289" y="1124870"/>
            <a:ext cx="1554803" cy="254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266386B-F9A6-5643-9ED7-389EC9DEEDC8}"/>
              </a:ext>
            </a:extLst>
          </p:cNvPr>
          <p:cNvSpPr txBox="1"/>
          <p:nvPr/>
        </p:nvSpPr>
        <p:spPr>
          <a:xfrm>
            <a:off x="10057842" y="1102172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ERK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7961805-599A-03FD-CE2E-374AA993D583}"/>
              </a:ext>
            </a:extLst>
          </p:cNvPr>
          <p:cNvSpPr/>
          <p:nvPr/>
        </p:nvSpPr>
        <p:spPr>
          <a:xfrm>
            <a:off x="3112656" y="5203712"/>
            <a:ext cx="1644308" cy="2656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A2CAF8-C5AC-9A40-63D0-F169390C421C}"/>
              </a:ext>
            </a:extLst>
          </p:cNvPr>
          <p:cNvSpPr txBox="1"/>
          <p:nvPr/>
        </p:nvSpPr>
        <p:spPr>
          <a:xfrm>
            <a:off x="4756963" y="5203712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1671292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0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3</cp:revision>
  <dcterms:created xsi:type="dcterms:W3CDTF">2024-08-31T22:19:33Z</dcterms:created>
  <dcterms:modified xsi:type="dcterms:W3CDTF">2024-08-31T22:50:55Z</dcterms:modified>
</cp:coreProperties>
</file>